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5">
  <p:sldMasterIdLst>
    <p:sldMasterId id="2147483648" r:id="rId1"/>
  </p:sldMasterIdLst>
  <p:notesMasterIdLst>
    <p:notesMasterId r:id="rId3"/>
  </p:notesMasterIdLst>
  <p:sldIdLst>
    <p:sldId id="35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18CDF"/>
    <a:srgbClr val="16A8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749" autoAdjust="0"/>
    <p:restoredTop sz="88454" autoAdjust="0"/>
  </p:normalViewPr>
  <p:slideViewPr>
    <p:cSldViewPr>
      <p:cViewPr varScale="1">
        <p:scale>
          <a:sx n="85" d="100"/>
          <a:sy n="85" d="100"/>
        </p:scale>
        <p:origin x="2886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2FAFD0-EF8C-554B-B034-4442DE591FA0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B1FB10-D472-764B-87F9-C134BDEA3E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1839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CB1FB10-D472-764B-87F9-C134BDEA3E1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23659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81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4337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8408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8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8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487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8122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3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80949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7935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5369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91372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465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1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7" y="36408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10" y="191348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1396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8140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1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4334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083A204F-B7D7-1D9B-6CBE-B009CD44757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95904688"/>
              </p:ext>
            </p:extLst>
          </p:nvPr>
        </p:nvGraphicFramePr>
        <p:xfrm>
          <a:off x="1295400" y="495300"/>
          <a:ext cx="4189413" cy="60277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6786037" imgH="9762335" progId="Prism10.Document">
                  <p:embed/>
                </p:oleObj>
              </mc:Choice>
              <mc:Fallback>
                <p:oleObj name="Prism 10" r:id="rId3" imgW="6786037" imgH="9762335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083A204F-B7D7-1D9B-6CBE-B009CD44757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95400" y="495300"/>
                        <a:ext cx="4189413" cy="60277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CC9878DB-E1ED-54B5-15F8-42F510FE39B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9486387"/>
              </p:ext>
            </p:extLst>
          </p:nvPr>
        </p:nvGraphicFramePr>
        <p:xfrm>
          <a:off x="1301750" y="6634163"/>
          <a:ext cx="2647950" cy="1939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4346478" imgH="3189524" progId="Prism10.Document">
                  <p:embed/>
                </p:oleObj>
              </mc:Choice>
              <mc:Fallback>
                <p:oleObj name="Prism 10" r:id="rId5" imgW="4346478" imgH="3189524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CC9878DB-E1ED-54B5-15F8-42F510FE39B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301750" y="6634163"/>
                        <a:ext cx="2647950" cy="1939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0" name="Group 19">
            <a:extLst>
              <a:ext uri="{FF2B5EF4-FFF2-40B4-BE49-F238E27FC236}">
                <a16:creationId xmlns:a16="http://schemas.microsoft.com/office/drawing/2014/main" id="{6A7AACE9-DD65-5F68-095D-FA4E7EB5109C}"/>
              </a:ext>
            </a:extLst>
          </p:cNvPr>
          <p:cNvGrpSpPr/>
          <p:nvPr/>
        </p:nvGrpSpPr>
        <p:grpSpPr>
          <a:xfrm>
            <a:off x="1311570" y="2375356"/>
            <a:ext cx="1234942" cy="215444"/>
            <a:chOff x="1371600" y="1897073"/>
            <a:chExt cx="1234942" cy="215444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0C1652C-64AF-DE40-8DCD-9306427DF2F2}"/>
                </a:ext>
              </a:extLst>
            </p:cNvPr>
            <p:cNvSpPr txBox="1"/>
            <p:nvPr/>
          </p:nvSpPr>
          <p:spPr>
            <a:xfrm>
              <a:off x="1371600" y="1897073"/>
              <a:ext cx="7312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/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+vehicle</a:t>
              </a:r>
              <a:endParaRPr lang="en-US" sz="800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69A3290-4972-F2F7-D607-32841B182F4C}"/>
                </a:ext>
              </a:extLst>
            </p:cNvPr>
            <p:cNvSpPr txBox="1"/>
            <p:nvPr/>
          </p:nvSpPr>
          <p:spPr>
            <a:xfrm>
              <a:off x="1965030" y="1901037"/>
              <a:ext cx="641512" cy="20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/P+C458</a:t>
              </a:r>
              <a:endParaRPr lang="en-US" sz="800" dirty="0"/>
            </a:p>
          </p:txBody>
        </p: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A9DB5AAE-EBD5-1136-F9B0-8E5D53BEA013}"/>
              </a:ext>
            </a:extLst>
          </p:cNvPr>
          <p:cNvGrpSpPr/>
          <p:nvPr/>
        </p:nvGrpSpPr>
        <p:grpSpPr>
          <a:xfrm>
            <a:off x="2743200" y="2375356"/>
            <a:ext cx="1251112" cy="215444"/>
            <a:chOff x="1371600" y="1897073"/>
            <a:chExt cx="1251112" cy="215444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BFF6AE97-78C2-37C1-2F60-D76C8F557B19}"/>
                </a:ext>
              </a:extLst>
            </p:cNvPr>
            <p:cNvSpPr txBox="1"/>
            <p:nvPr/>
          </p:nvSpPr>
          <p:spPr>
            <a:xfrm>
              <a:off x="1371600" y="1897073"/>
              <a:ext cx="7312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/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+vehicle</a:t>
              </a:r>
              <a:endParaRPr lang="en-US" sz="800" dirty="0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1DCB38EC-1B6F-9BE5-B7B1-AD2C5F0DBBA1}"/>
                </a:ext>
              </a:extLst>
            </p:cNvPr>
            <p:cNvSpPr txBox="1"/>
            <p:nvPr/>
          </p:nvSpPr>
          <p:spPr>
            <a:xfrm>
              <a:off x="1981200" y="1901037"/>
              <a:ext cx="641512" cy="20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/P+C458</a:t>
              </a:r>
              <a:endParaRPr lang="en-US" sz="800" dirty="0"/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9A43F38D-0B27-535B-FE52-315E53DBDFB0}"/>
              </a:ext>
            </a:extLst>
          </p:cNvPr>
          <p:cNvGrpSpPr/>
          <p:nvPr/>
        </p:nvGrpSpPr>
        <p:grpSpPr>
          <a:xfrm>
            <a:off x="4191000" y="2375356"/>
            <a:ext cx="1251112" cy="215444"/>
            <a:chOff x="1371600" y="1897073"/>
            <a:chExt cx="1251112" cy="215444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DCD21267-206C-6B4A-6C3D-BCE08BC3F777}"/>
                </a:ext>
              </a:extLst>
            </p:cNvPr>
            <p:cNvSpPr txBox="1"/>
            <p:nvPr/>
          </p:nvSpPr>
          <p:spPr>
            <a:xfrm>
              <a:off x="1371600" y="1897073"/>
              <a:ext cx="7312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/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+vehicle</a:t>
              </a:r>
              <a:endParaRPr lang="en-US" sz="800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1D5609D-D1AD-7AED-EDD0-986D5238BD3E}"/>
                </a:ext>
              </a:extLst>
            </p:cNvPr>
            <p:cNvSpPr txBox="1"/>
            <p:nvPr/>
          </p:nvSpPr>
          <p:spPr>
            <a:xfrm>
              <a:off x="1981200" y="1901037"/>
              <a:ext cx="641512" cy="20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/P+C458</a:t>
              </a:r>
              <a:endParaRPr lang="en-US" sz="800" dirty="0"/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0A62EE47-4ADB-6B9B-C6FA-50EF533DDF27}"/>
              </a:ext>
            </a:extLst>
          </p:cNvPr>
          <p:cNvGrpSpPr/>
          <p:nvPr/>
        </p:nvGrpSpPr>
        <p:grpSpPr>
          <a:xfrm>
            <a:off x="1286971" y="4301337"/>
            <a:ext cx="1234942" cy="215444"/>
            <a:chOff x="1371600" y="1897073"/>
            <a:chExt cx="1234942" cy="215444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CA7D352B-9330-2EE6-65AF-DEC7FBE4FC51}"/>
                </a:ext>
              </a:extLst>
            </p:cNvPr>
            <p:cNvSpPr txBox="1"/>
            <p:nvPr/>
          </p:nvSpPr>
          <p:spPr>
            <a:xfrm>
              <a:off x="1371600" y="1897073"/>
              <a:ext cx="7312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/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+vehicle</a:t>
              </a:r>
              <a:endParaRPr lang="en-US" sz="800" dirty="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A54B0132-F320-DC4B-CEDA-2EB522735356}"/>
                </a:ext>
              </a:extLst>
            </p:cNvPr>
            <p:cNvSpPr txBox="1"/>
            <p:nvPr/>
          </p:nvSpPr>
          <p:spPr>
            <a:xfrm>
              <a:off x="1965030" y="1901037"/>
              <a:ext cx="641512" cy="20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/P+C458</a:t>
              </a:r>
              <a:endParaRPr lang="en-US" sz="800" dirty="0"/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6CE7ADFB-9CF4-22A1-CEAD-EB15A967055E}"/>
              </a:ext>
            </a:extLst>
          </p:cNvPr>
          <p:cNvGrpSpPr/>
          <p:nvPr/>
        </p:nvGrpSpPr>
        <p:grpSpPr>
          <a:xfrm>
            <a:off x="2718601" y="4305300"/>
            <a:ext cx="1251112" cy="215444"/>
            <a:chOff x="1371600" y="1897073"/>
            <a:chExt cx="1251112" cy="215444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9DAC779D-E539-0591-3E9C-630AB80F1D91}"/>
                </a:ext>
              </a:extLst>
            </p:cNvPr>
            <p:cNvSpPr txBox="1"/>
            <p:nvPr/>
          </p:nvSpPr>
          <p:spPr>
            <a:xfrm>
              <a:off x="1371600" y="1897073"/>
              <a:ext cx="7312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/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+vehicle</a:t>
              </a:r>
              <a:endParaRPr lang="en-US" sz="800" dirty="0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91C4866-2018-492A-641F-E7815BCA11C5}"/>
                </a:ext>
              </a:extLst>
            </p:cNvPr>
            <p:cNvSpPr txBox="1"/>
            <p:nvPr/>
          </p:nvSpPr>
          <p:spPr>
            <a:xfrm>
              <a:off x="1981200" y="1901037"/>
              <a:ext cx="641512" cy="20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/P+C458</a:t>
              </a:r>
              <a:endParaRPr lang="en-US" sz="800" dirty="0"/>
            </a:p>
          </p:txBody>
        </p: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F2D435C1-7C97-33D7-A1A4-23B79B40B2D2}"/>
              </a:ext>
            </a:extLst>
          </p:cNvPr>
          <p:cNvGrpSpPr/>
          <p:nvPr/>
        </p:nvGrpSpPr>
        <p:grpSpPr>
          <a:xfrm>
            <a:off x="4166401" y="4305300"/>
            <a:ext cx="1251112" cy="215444"/>
            <a:chOff x="1371600" y="1897073"/>
            <a:chExt cx="1251112" cy="215444"/>
          </a:xfrm>
        </p:grpSpPr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2F28FBD9-BF67-EF63-F4DB-F866F0523146}"/>
                </a:ext>
              </a:extLst>
            </p:cNvPr>
            <p:cNvSpPr txBox="1"/>
            <p:nvPr/>
          </p:nvSpPr>
          <p:spPr>
            <a:xfrm>
              <a:off x="1371600" y="1897073"/>
              <a:ext cx="7312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/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+vehicle</a:t>
              </a:r>
              <a:endParaRPr lang="en-US" sz="800" dirty="0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3D0A8009-9E74-ABB3-C639-2C231E30FD0B}"/>
                </a:ext>
              </a:extLst>
            </p:cNvPr>
            <p:cNvSpPr txBox="1"/>
            <p:nvPr/>
          </p:nvSpPr>
          <p:spPr>
            <a:xfrm>
              <a:off x="1981200" y="1901037"/>
              <a:ext cx="641512" cy="20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/P+C458</a:t>
              </a:r>
              <a:endParaRPr lang="en-US" sz="800" dirty="0"/>
            </a:p>
          </p:txBody>
        </p: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AAC1F2E8-E18C-B72B-FBDA-BDB6B2AE9802}"/>
              </a:ext>
            </a:extLst>
          </p:cNvPr>
          <p:cNvGrpSpPr/>
          <p:nvPr/>
        </p:nvGrpSpPr>
        <p:grpSpPr>
          <a:xfrm>
            <a:off x="1332753" y="6333793"/>
            <a:ext cx="1234942" cy="215444"/>
            <a:chOff x="1371600" y="1897073"/>
            <a:chExt cx="1234942" cy="215444"/>
          </a:xfrm>
        </p:grpSpPr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11DCC172-0958-9485-1844-BDA000601179}"/>
                </a:ext>
              </a:extLst>
            </p:cNvPr>
            <p:cNvSpPr txBox="1"/>
            <p:nvPr/>
          </p:nvSpPr>
          <p:spPr>
            <a:xfrm>
              <a:off x="1371600" y="1897073"/>
              <a:ext cx="7312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/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+vehicle</a:t>
              </a:r>
              <a:endParaRPr lang="en-US" sz="800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7A359D2-F8D4-1EF1-2245-8E7E30A17892}"/>
                </a:ext>
              </a:extLst>
            </p:cNvPr>
            <p:cNvSpPr txBox="1"/>
            <p:nvPr/>
          </p:nvSpPr>
          <p:spPr>
            <a:xfrm>
              <a:off x="1965030" y="1901037"/>
              <a:ext cx="641512" cy="20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/P+C458</a:t>
              </a:r>
              <a:endParaRPr lang="en-US" sz="800" dirty="0"/>
            </a:p>
          </p:txBody>
        </p: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D858171B-B594-568B-DFC9-F5F172C7EF6E}"/>
              </a:ext>
            </a:extLst>
          </p:cNvPr>
          <p:cNvGrpSpPr/>
          <p:nvPr/>
        </p:nvGrpSpPr>
        <p:grpSpPr>
          <a:xfrm>
            <a:off x="2764383" y="6337756"/>
            <a:ext cx="1251112" cy="215444"/>
            <a:chOff x="1371600" y="1897073"/>
            <a:chExt cx="1251112" cy="215444"/>
          </a:xfrm>
        </p:grpSpPr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DC616346-74EE-4ADE-DDBC-43C56DEF279D}"/>
                </a:ext>
              </a:extLst>
            </p:cNvPr>
            <p:cNvSpPr txBox="1"/>
            <p:nvPr/>
          </p:nvSpPr>
          <p:spPr>
            <a:xfrm>
              <a:off x="1371600" y="1897073"/>
              <a:ext cx="7312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/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+vehicle</a:t>
              </a:r>
              <a:endParaRPr lang="en-US" sz="800" dirty="0"/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2CCE08D8-6B8C-0C0D-DBB5-17606EFA6C58}"/>
                </a:ext>
              </a:extLst>
            </p:cNvPr>
            <p:cNvSpPr txBox="1"/>
            <p:nvPr/>
          </p:nvSpPr>
          <p:spPr>
            <a:xfrm>
              <a:off x="1981200" y="1901037"/>
              <a:ext cx="641512" cy="20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/P+C458</a:t>
              </a:r>
              <a:endParaRPr lang="en-US" sz="800" dirty="0"/>
            </a:p>
          </p:txBody>
        </p: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711AD8FF-83AA-CA3D-7AAC-37D4FC614734}"/>
              </a:ext>
            </a:extLst>
          </p:cNvPr>
          <p:cNvGrpSpPr/>
          <p:nvPr/>
        </p:nvGrpSpPr>
        <p:grpSpPr>
          <a:xfrm>
            <a:off x="4212183" y="6337756"/>
            <a:ext cx="1251112" cy="215444"/>
            <a:chOff x="1371600" y="1897073"/>
            <a:chExt cx="1251112" cy="215444"/>
          </a:xfrm>
        </p:grpSpPr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BF3A9B1C-312A-FD25-9D76-BDF28E234506}"/>
                </a:ext>
              </a:extLst>
            </p:cNvPr>
            <p:cNvSpPr txBox="1"/>
            <p:nvPr/>
          </p:nvSpPr>
          <p:spPr>
            <a:xfrm>
              <a:off x="1371600" y="1897073"/>
              <a:ext cx="7312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/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+vehicle</a:t>
              </a:r>
              <a:endParaRPr lang="en-US" sz="800" dirty="0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DF7E65C4-9EEB-E9CF-2E51-F9FC9B47B805}"/>
                </a:ext>
              </a:extLst>
            </p:cNvPr>
            <p:cNvSpPr txBox="1"/>
            <p:nvPr/>
          </p:nvSpPr>
          <p:spPr>
            <a:xfrm>
              <a:off x="1981200" y="1901037"/>
              <a:ext cx="641512" cy="20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/P+C458</a:t>
              </a:r>
              <a:endParaRPr lang="en-US" sz="800" dirty="0"/>
            </a:p>
          </p:txBody>
        </p: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61026CC6-35CF-48E1-E8C2-6086C236AF8C}"/>
              </a:ext>
            </a:extLst>
          </p:cNvPr>
          <p:cNvGrpSpPr/>
          <p:nvPr/>
        </p:nvGrpSpPr>
        <p:grpSpPr>
          <a:xfrm>
            <a:off x="1332753" y="8381779"/>
            <a:ext cx="1234942" cy="215444"/>
            <a:chOff x="1371600" y="1897073"/>
            <a:chExt cx="1234942" cy="215444"/>
          </a:xfrm>
        </p:grpSpPr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D384D68B-A0BF-7A5A-4310-68AEC90F7936}"/>
                </a:ext>
              </a:extLst>
            </p:cNvPr>
            <p:cNvSpPr txBox="1"/>
            <p:nvPr/>
          </p:nvSpPr>
          <p:spPr>
            <a:xfrm>
              <a:off x="1371600" y="1897073"/>
              <a:ext cx="7312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/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+vehicle</a:t>
              </a:r>
              <a:endParaRPr lang="en-US" sz="800" dirty="0"/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575D4474-8714-D497-C32E-B4294F9ABC0F}"/>
                </a:ext>
              </a:extLst>
            </p:cNvPr>
            <p:cNvSpPr txBox="1"/>
            <p:nvPr/>
          </p:nvSpPr>
          <p:spPr>
            <a:xfrm>
              <a:off x="1965030" y="1901037"/>
              <a:ext cx="641512" cy="20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/P+C458</a:t>
              </a:r>
              <a:endParaRPr lang="en-US" sz="800" dirty="0"/>
            </a:p>
          </p:txBody>
        </p:sp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id="{B5F7B506-0B0A-B5C7-1D6D-C7AF2CD097BF}"/>
              </a:ext>
            </a:extLst>
          </p:cNvPr>
          <p:cNvGrpSpPr/>
          <p:nvPr/>
        </p:nvGrpSpPr>
        <p:grpSpPr>
          <a:xfrm>
            <a:off x="2764383" y="8385742"/>
            <a:ext cx="1251112" cy="215444"/>
            <a:chOff x="1371600" y="1897073"/>
            <a:chExt cx="1251112" cy="215444"/>
          </a:xfrm>
        </p:grpSpPr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9F605CBB-40F0-FA0D-A0BC-FFB11411C607}"/>
                </a:ext>
              </a:extLst>
            </p:cNvPr>
            <p:cNvSpPr txBox="1"/>
            <p:nvPr/>
          </p:nvSpPr>
          <p:spPr>
            <a:xfrm>
              <a:off x="1371600" y="1897073"/>
              <a:ext cx="7312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/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+vehicle</a:t>
              </a:r>
              <a:endParaRPr lang="en-US" sz="800" dirty="0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18C73D4B-0A43-EA64-935C-9A84453C7F4F}"/>
                </a:ext>
              </a:extLst>
            </p:cNvPr>
            <p:cNvSpPr txBox="1"/>
            <p:nvPr/>
          </p:nvSpPr>
          <p:spPr>
            <a:xfrm>
              <a:off x="1981200" y="1901037"/>
              <a:ext cx="641512" cy="20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/P+C458</a:t>
              </a:r>
              <a:endParaRPr lang="en-US" sz="800" dirty="0"/>
            </a:p>
          </p:txBody>
        </p:sp>
      </p:grpSp>
      <p:sp>
        <p:nvSpPr>
          <p:cNvPr id="54" name="TextBox 53">
            <a:extLst>
              <a:ext uri="{FF2B5EF4-FFF2-40B4-BE49-F238E27FC236}">
                <a16:creationId xmlns:a16="http://schemas.microsoft.com/office/drawing/2014/main" id="{A53D76D9-51B6-7BE5-A296-1041DA468552}"/>
              </a:ext>
            </a:extLst>
          </p:cNvPr>
          <p:cNvSpPr txBox="1"/>
          <p:nvPr/>
        </p:nvSpPr>
        <p:spPr>
          <a:xfrm>
            <a:off x="1630618" y="370237"/>
            <a:ext cx="8912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r>
              <a:rPr lang="en-US" sz="800" b="1" dirty="0" err="1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endParaRPr lang="en-US" sz="8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DAEC182B-CD76-B378-DEAC-F2741550E591}"/>
              </a:ext>
            </a:extLst>
          </p:cNvPr>
          <p:cNvSpPr txBox="1"/>
          <p:nvPr/>
        </p:nvSpPr>
        <p:spPr>
          <a:xfrm>
            <a:off x="3156668" y="370237"/>
            <a:ext cx="8912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-ACC</a:t>
            </a:r>
            <a:endParaRPr lang="en-US" sz="8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2C85F3B9-091D-AC62-C412-B960E6A2425E}"/>
              </a:ext>
            </a:extLst>
          </p:cNvPr>
          <p:cNvSpPr txBox="1"/>
          <p:nvPr/>
        </p:nvSpPr>
        <p:spPr>
          <a:xfrm>
            <a:off x="4497825" y="304800"/>
            <a:ext cx="8912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-PGC1</a:t>
            </a:r>
            <a:r>
              <a:rPr lang="en-US" sz="800" b="1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01A0CAC2-29AB-5955-C463-322AB8358401}"/>
              </a:ext>
            </a:extLst>
          </p:cNvPr>
          <p:cNvSpPr txBox="1"/>
          <p:nvPr/>
        </p:nvSpPr>
        <p:spPr>
          <a:xfrm>
            <a:off x="4542181" y="2555312"/>
            <a:ext cx="8912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-Akt</a:t>
            </a:r>
            <a:endParaRPr lang="en-US" sz="8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39816140-A867-1E67-734F-390E95195F28}"/>
              </a:ext>
            </a:extLst>
          </p:cNvPr>
          <p:cNvSpPr txBox="1"/>
          <p:nvPr/>
        </p:nvSpPr>
        <p:spPr>
          <a:xfrm>
            <a:off x="3064178" y="2556561"/>
            <a:ext cx="8912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-ULK1 S317</a:t>
            </a:r>
            <a:endParaRPr lang="en-US" sz="8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78C8D3F-2868-840D-0547-D836BD1B704B}"/>
              </a:ext>
            </a:extLst>
          </p:cNvPr>
          <p:cNvSpPr txBox="1"/>
          <p:nvPr/>
        </p:nvSpPr>
        <p:spPr>
          <a:xfrm>
            <a:off x="1605641" y="2555312"/>
            <a:ext cx="8912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-ULK1 S555</a:t>
            </a:r>
            <a:endParaRPr lang="en-US" sz="8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DA0104C-826B-165D-E7CC-42A2E09BF1EC}"/>
              </a:ext>
            </a:extLst>
          </p:cNvPr>
          <p:cNvSpPr txBox="1"/>
          <p:nvPr/>
        </p:nvSpPr>
        <p:spPr>
          <a:xfrm>
            <a:off x="2973078" y="4560332"/>
            <a:ext cx="9704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-FOXO1A S256</a:t>
            </a:r>
            <a:endParaRPr lang="en-US" sz="8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0B71652B-8263-1EC4-0594-251676F37535}"/>
              </a:ext>
            </a:extLst>
          </p:cNvPr>
          <p:cNvSpPr txBox="1"/>
          <p:nvPr/>
        </p:nvSpPr>
        <p:spPr>
          <a:xfrm>
            <a:off x="4336541" y="4540478"/>
            <a:ext cx="9704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-FOXO3A S253</a:t>
            </a:r>
            <a:endParaRPr lang="en-US" sz="8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EF66199B-D9D8-EB24-2EA5-253C161EF7C6}"/>
              </a:ext>
            </a:extLst>
          </p:cNvPr>
          <p:cNvSpPr txBox="1"/>
          <p:nvPr/>
        </p:nvSpPr>
        <p:spPr>
          <a:xfrm>
            <a:off x="1541885" y="4595695"/>
            <a:ext cx="9704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-Gsk3</a:t>
            </a:r>
            <a:r>
              <a:rPr lang="en-US" sz="800" b="1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8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6BBBD072-FD58-C023-4D1A-C34C31A80DE4}"/>
              </a:ext>
            </a:extLst>
          </p:cNvPr>
          <p:cNvSpPr txBox="1"/>
          <p:nvPr/>
        </p:nvSpPr>
        <p:spPr>
          <a:xfrm>
            <a:off x="1740229" y="6651869"/>
            <a:ext cx="9704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irt1</a:t>
            </a:r>
            <a:endParaRPr lang="en-US" sz="8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E3687EE5-BB5B-BF55-49F2-6D664D44BCCC}"/>
              </a:ext>
            </a:extLst>
          </p:cNvPr>
          <p:cNvSpPr txBox="1"/>
          <p:nvPr/>
        </p:nvSpPr>
        <p:spPr>
          <a:xfrm>
            <a:off x="3090669" y="6599005"/>
            <a:ext cx="9704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irt3</a:t>
            </a:r>
            <a:endParaRPr lang="en-US" sz="8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71FCD3C-86AF-8AB7-DEC7-30CEF251BC18}"/>
              </a:ext>
            </a:extLst>
          </p:cNvPr>
          <p:cNvSpPr txBox="1"/>
          <p:nvPr/>
        </p:nvSpPr>
        <p:spPr>
          <a:xfrm>
            <a:off x="50160" y="8700700"/>
            <a:ext cx="664764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/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5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antification of proteins presented on the Western blot in Fig. 7e</a:t>
            </a:r>
            <a:endParaRPr lang="en-US" sz="1200" dirty="0">
              <a:effectLst/>
              <a:latin typeface="Aptos" panose="020B00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14594CA-1876-578B-5737-082A96C6E48E}"/>
              </a:ext>
            </a:extLst>
          </p:cNvPr>
          <p:cNvSpPr txBox="1"/>
          <p:nvPr/>
        </p:nvSpPr>
        <p:spPr>
          <a:xfrm rot="16200000">
            <a:off x="766214" y="1292348"/>
            <a:ext cx="10583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r>
              <a:rPr lang="en-US" sz="800" dirty="0" err="1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/actin</a:t>
            </a:r>
            <a:endParaRPr lang="en-US" sz="8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35613FC-31AB-1BF5-DCA9-BD760129FE8D}"/>
              </a:ext>
            </a:extLst>
          </p:cNvPr>
          <p:cNvSpPr txBox="1"/>
          <p:nvPr/>
        </p:nvSpPr>
        <p:spPr>
          <a:xfrm rot="16200000">
            <a:off x="2372786" y="1292347"/>
            <a:ext cx="8912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ACC/actin</a:t>
            </a:r>
            <a:endParaRPr lang="en-US" sz="8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4DE5E4A-31A1-4567-45C2-932B2E5DB5AB}"/>
              </a:ext>
            </a:extLst>
          </p:cNvPr>
          <p:cNvSpPr txBox="1"/>
          <p:nvPr/>
        </p:nvSpPr>
        <p:spPr>
          <a:xfrm rot="16200000">
            <a:off x="3766535" y="1391526"/>
            <a:ext cx="8912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PGC1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/actin</a:t>
            </a:r>
            <a:endParaRPr lang="en-US" sz="8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7C4EE19-BAEE-2306-DE2A-D452FE999B6A}"/>
              </a:ext>
            </a:extLst>
          </p:cNvPr>
          <p:cNvSpPr txBox="1"/>
          <p:nvPr/>
        </p:nvSpPr>
        <p:spPr>
          <a:xfrm rot="16200000">
            <a:off x="738985" y="3427049"/>
            <a:ext cx="11875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ULK1 S555/actin</a:t>
            </a:r>
            <a:endParaRPr lang="en-US" sz="8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47EC9FB-DFE3-E1E4-09CA-53B5E59F8D6F}"/>
              </a:ext>
            </a:extLst>
          </p:cNvPr>
          <p:cNvSpPr txBox="1"/>
          <p:nvPr/>
        </p:nvSpPr>
        <p:spPr>
          <a:xfrm rot="16200000">
            <a:off x="2127250" y="3340328"/>
            <a:ext cx="12742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ULK1 S317/actin</a:t>
            </a:r>
            <a:endParaRPr lang="en-US" sz="8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CA9226A-76F1-3AF4-28C1-78AD4DABD7FA}"/>
              </a:ext>
            </a:extLst>
          </p:cNvPr>
          <p:cNvSpPr txBox="1"/>
          <p:nvPr/>
        </p:nvSpPr>
        <p:spPr>
          <a:xfrm rot="16200000">
            <a:off x="3747027" y="3427048"/>
            <a:ext cx="8912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Akt/actin</a:t>
            </a:r>
            <a:endParaRPr lang="en-US" sz="8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970414A-928F-6A4F-28B6-95DB8E9DACB9}"/>
              </a:ext>
            </a:extLst>
          </p:cNvPr>
          <p:cNvSpPr txBox="1"/>
          <p:nvPr/>
        </p:nvSpPr>
        <p:spPr>
          <a:xfrm rot="16200000">
            <a:off x="826329" y="5468839"/>
            <a:ext cx="9704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Gsk3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/actin </a:t>
            </a:r>
            <a:endParaRPr lang="en-US" sz="8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C784FD9-DF24-2216-D7E0-552B0F3BCF14}"/>
              </a:ext>
            </a:extLst>
          </p:cNvPr>
          <p:cNvSpPr txBox="1"/>
          <p:nvPr/>
        </p:nvSpPr>
        <p:spPr>
          <a:xfrm rot="16200000">
            <a:off x="2124987" y="5484823"/>
            <a:ext cx="12787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FOXO1A S256/ actin</a:t>
            </a:r>
            <a:endParaRPr lang="en-US" sz="8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2C6FD80-DA43-2A72-5FAF-D63E460C3149}"/>
              </a:ext>
            </a:extLst>
          </p:cNvPr>
          <p:cNvSpPr txBox="1"/>
          <p:nvPr/>
        </p:nvSpPr>
        <p:spPr>
          <a:xfrm rot="16200000">
            <a:off x="3511296" y="5439117"/>
            <a:ext cx="13702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-FOXO3A S253/ actin</a:t>
            </a:r>
            <a:endParaRPr lang="en-US" sz="8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D17674D-3405-29BB-25EA-88A23BB13A47}"/>
              </a:ext>
            </a:extLst>
          </p:cNvPr>
          <p:cNvSpPr txBox="1"/>
          <p:nvPr/>
        </p:nvSpPr>
        <p:spPr>
          <a:xfrm rot="16200000">
            <a:off x="826330" y="7378094"/>
            <a:ext cx="9704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irt1/ actin</a:t>
            </a:r>
            <a:endParaRPr lang="en-US" sz="8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B94DCF6-D848-D2E8-58D8-AE3C38866DC5}"/>
              </a:ext>
            </a:extLst>
          </p:cNvPr>
          <p:cNvSpPr txBox="1"/>
          <p:nvPr/>
        </p:nvSpPr>
        <p:spPr>
          <a:xfrm rot="16200000">
            <a:off x="2257959" y="7399849"/>
            <a:ext cx="9704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irt3/ actin</a:t>
            </a:r>
            <a:endParaRPr lang="en-US" sz="8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56567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50713</TotalTime>
  <Words>179</Words>
  <Application>Microsoft Office PowerPoint</Application>
  <PresentationFormat>On-screen Show (4:3)</PresentationFormat>
  <Paragraphs>46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rial</vt:lpstr>
      <vt:lpstr>Calibri</vt:lpstr>
      <vt:lpstr>Symbol</vt:lpstr>
      <vt:lpstr>Office Theme</vt:lpstr>
      <vt:lpstr>Prism 10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gey A Trushin</dc:creator>
  <cp:lastModifiedBy>Trushin, Sergey A., Ph.D.</cp:lastModifiedBy>
  <cp:revision>604</cp:revision>
  <cp:lastPrinted>2022-11-09T15:46:24Z</cp:lastPrinted>
  <dcterms:created xsi:type="dcterms:W3CDTF">2020-01-31T17:27:01Z</dcterms:created>
  <dcterms:modified xsi:type="dcterms:W3CDTF">2025-02-12T20:30:13Z</dcterms:modified>
</cp:coreProperties>
</file>